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37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294" autoAdjust="0"/>
    <p:restoredTop sz="88033" autoAdjust="0"/>
  </p:normalViewPr>
  <p:slideViewPr>
    <p:cSldViewPr snapToGrid="0">
      <p:cViewPr varScale="1">
        <p:scale>
          <a:sx n="63" d="100"/>
          <a:sy n="63" d="100"/>
        </p:scale>
        <p:origin x="92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A462F6-885A-486E-A56F-1B29FF9F9615}" type="datetimeFigureOut">
              <a:rPr lang="en-ZA" smtClean="0"/>
              <a:t>2021/04/23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590B6-206D-4F5B-80A3-9E1F0A07C064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252506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803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77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698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2577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606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568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890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472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330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912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629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0F20B-FF87-40CD-B752-AC27B3439A80}" type="datetimeFigureOut">
              <a:rPr lang="en-US" smtClean="0"/>
              <a:t>4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730F00-B82B-457D-ADDA-5D09540FD9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57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696757E-82E9-475A-9CD9-1A3A96353924}"/>
              </a:ext>
            </a:extLst>
          </p:cNvPr>
          <p:cNvSpPr txBox="1"/>
          <p:nvPr/>
        </p:nvSpPr>
        <p:spPr>
          <a:xfrm>
            <a:off x="4323347" y="529389"/>
            <a:ext cx="29348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Alert Trigger &amp; Referral Form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EE16720-E0CD-4319-B23D-213D401B5E01}"/>
              </a:ext>
            </a:extLst>
          </p:cNvPr>
          <p:cNvSpPr txBox="1"/>
          <p:nvPr/>
        </p:nvSpPr>
        <p:spPr>
          <a:xfrm>
            <a:off x="593550" y="1555585"/>
            <a:ext cx="41781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Patient Name:_______________________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50F1D8-F80A-4D86-B0B2-CC5AA7A530B9}"/>
              </a:ext>
            </a:extLst>
          </p:cNvPr>
          <p:cNvSpPr txBox="1"/>
          <p:nvPr/>
        </p:nvSpPr>
        <p:spPr>
          <a:xfrm>
            <a:off x="593549" y="2028827"/>
            <a:ext cx="41422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Sex:_______________________________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2333C59-B2A1-4E22-AB27-3E076A830FA1}"/>
              </a:ext>
            </a:extLst>
          </p:cNvPr>
          <p:cNvSpPr txBox="1"/>
          <p:nvPr/>
        </p:nvSpPr>
        <p:spPr>
          <a:xfrm>
            <a:off x="1884940" y="2028827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Mal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4C5CE2-9369-4A5E-9569-3B51F5BA850D}"/>
              </a:ext>
            </a:extLst>
          </p:cNvPr>
          <p:cNvSpPr txBox="1"/>
          <p:nvPr/>
        </p:nvSpPr>
        <p:spPr>
          <a:xfrm>
            <a:off x="3310356" y="2028827"/>
            <a:ext cx="865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Femal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BDA2871-C4A2-47E0-91AB-2B6AA0B04EB5}"/>
              </a:ext>
            </a:extLst>
          </p:cNvPr>
          <p:cNvSpPr/>
          <p:nvPr/>
        </p:nvSpPr>
        <p:spPr>
          <a:xfrm>
            <a:off x="1905049" y="3919172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E6A3A64-EEEE-4351-B45D-131E55AE04DA}"/>
              </a:ext>
            </a:extLst>
          </p:cNvPr>
          <p:cNvSpPr/>
          <p:nvPr/>
        </p:nvSpPr>
        <p:spPr>
          <a:xfrm>
            <a:off x="3144247" y="2133281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23D560-D237-4529-B64D-016E6830C255}"/>
              </a:ext>
            </a:extLst>
          </p:cNvPr>
          <p:cNvSpPr txBox="1"/>
          <p:nvPr/>
        </p:nvSpPr>
        <p:spPr>
          <a:xfrm>
            <a:off x="593549" y="1186253"/>
            <a:ext cx="41506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Date:______________________________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C36DED2-6D42-4CE4-8CB5-9C0291189954}"/>
              </a:ext>
            </a:extLst>
          </p:cNvPr>
          <p:cNvSpPr txBox="1"/>
          <p:nvPr/>
        </p:nvSpPr>
        <p:spPr>
          <a:xfrm>
            <a:off x="593550" y="2502069"/>
            <a:ext cx="42051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Patient Age:_________________________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788A8A5-7522-4B53-8173-8CDF5C4E66B6}"/>
              </a:ext>
            </a:extLst>
          </p:cNvPr>
          <p:cNvSpPr txBox="1"/>
          <p:nvPr/>
        </p:nvSpPr>
        <p:spPr>
          <a:xfrm>
            <a:off x="2664277" y="2429516"/>
            <a:ext cx="672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Year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594C58A-9995-4AF2-8B36-E0351C90329A}"/>
              </a:ext>
            </a:extLst>
          </p:cNvPr>
          <p:cNvSpPr txBox="1"/>
          <p:nvPr/>
        </p:nvSpPr>
        <p:spPr>
          <a:xfrm>
            <a:off x="3872086" y="2421677"/>
            <a:ext cx="911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Months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0BBD5FCD-B9AA-49E2-A8AF-5B8F922ECAFB}"/>
              </a:ext>
            </a:extLst>
          </p:cNvPr>
          <p:cNvSpPr/>
          <p:nvPr/>
        </p:nvSpPr>
        <p:spPr>
          <a:xfrm>
            <a:off x="2358183" y="2429516"/>
            <a:ext cx="357276" cy="2807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2FAA7AB-CEEE-4D44-847B-F212249345D9}"/>
              </a:ext>
            </a:extLst>
          </p:cNvPr>
          <p:cNvSpPr/>
          <p:nvPr/>
        </p:nvSpPr>
        <p:spPr>
          <a:xfrm>
            <a:off x="3561341" y="2453217"/>
            <a:ext cx="377248" cy="2570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AD25B97-5D61-40E7-A465-6E9D4CF14355}"/>
              </a:ext>
            </a:extLst>
          </p:cNvPr>
          <p:cNvSpPr txBox="1"/>
          <p:nvPr/>
        </p:nvSpPr>
        <p:spPr>
          <a:xfrm>
            <a:off x="6619795" y="1001587"/>
            <a:ext cx="5378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Community:__________________________________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649D76B-2670-4DC8-AFE0-ABD041751826}"/>
              </a:ext>
            </a:extLst>
          </p:cNvPr>
          <p:cNvSpPr txBox="1"/>
          <p:nvPr/>
        </p:nvSpPr>
        <p:spPr>
          <a:xfrm>
            <a:off x="6619795" y="1424465"/>
            <a:ext cx="5466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Community Volunteer Name:_____________________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DD91302-371A-4E99-AC66-C5E8165FD633}"/>
              </a:ext>
            </a:extLst>
          </p:cNvPr>
          <p:cNvSpPr txBox="1"/>
          <p:nvPr/>
        </p:nvSpPr>
        <p:spPr>
          <a:xfrm>
            <a:off x="6619795" y="2215647"/>
            <a:ext cx="5344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Focal Point Name:______________________________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B73E59-C300-463F-BD77-F9DF64267A2A}"/>
              </a:ext>
            </a:extLst>
          </p:cNvPr>
          <p:cNvSpPr txBox="1"/>
          <p:nvPr/>
        </p:nvSpPr>
        <p:spPr>
          <a:xfrm>
            <a:off x="6619795" y="2585984"/>
            <a:ext cx="5401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Focal Point Phone Number:_______________________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B62DE1D-66F7-4F4B-9EA2-31A44D5BB29A}"/>
              </a:ext>
            </a:extLst>
          </p:cNvPr>
          <p:cNvSpPr txBox="1"/>
          <p:nvPr/>
        </p:nvSpPr>
        <p:spPr>
          <a:xfrm>
            <a:off x="6619795" y="1811346"/>
            <a:ext cx="5391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Community Volunteer Phone:_____________________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AD2114B-C9B6-4F8F-A211-A2FE096725A2}"/>
              </a:ext>
            </a:extLst>
          </p:cNvPr>
          <p:cNvCxnSpPr>
            <a:cxnSpLocks/>
          </p:cNvCxnSpPr>
          <p:nvPr/>
        </p:nvCxnSpPr>
        <p:spPr>
          <a:xfrm>
            <a:off x="661307" y="3502479"/>
            <a:ext cx="11313865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18C0D445-8F68-4AFE-B894-FD42CA90497E}"/>
              </a:ext>
            </a:extLst>
          </p:cNvPr>
          <p:cNvSpPr txBox="1"/>
          <p:nvPr/>
        </p:nvSpPr>
        <p:spPr>
          <a:xfrm rot="16200000">
            <a:off x="179491" y="4119428"/>
            <a:ext cx="1453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Alert Trigger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9295F68-CA36-4546-8A28-EA0076D34517}"/>
              </a:ext>
            </a:extLst>
          </p:cNvPr>
          <p:cNvSpPr txBox="1"/>
          <p:nvPr/>
        </p:nvSpPr>
        <p:spPr>
          <a:xfrm>
            <a:off x="2113596" y="3800134"/>
            <a:ext cx="2260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Influenza – Like Illnes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47AA80F-DAE4-458F-B7A2-316B18CD5094}"/>
              </a:ext>
            </a:extLst>
          </p:cNvPr>
          <p:cNvSpPr txBox="1"/>
          <p:nvPr/>
        </p:nvSpPr>
        <p:spPr>
          <a:xfrm>
            <a:off x="2113596" y="4225442"/>
            <a:ext cx="43669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Unknown Health Problem Grouped Together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D66050E-ADDE-4270-BF94-258DF6C1DDCA}"/>
              </a:ext>
            </a:extLst>
          </p:cNvPr>
          <p:cNvSpPr txBox="1"/>
          <p:nvPr/>
        </p:nvSpPr>
        <p:spPr>
          <a:xfrm>
            <a:off x="6619795" y="3040589"/>
            <a:ext cx="535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Nearest Health Facility:__________________________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FA8107-5A5A-4E05-B43D-720371DF692A}"/>
              </a:ext>
            </a:extLst>
          </p:cNvPr>
          <p:cNvSpPr txBox="1"/>
          <p:nvPr/>
        </p:nvSpPr>
        <p:spPr>
          <a:xfrm>
            <a:off x="7437681" y="3733219"/>
            <a:ext cx="26407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Other respiratory illnesse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1DE64DF-97BE-4740-826C-BBC8A3097EBD}"/>
              </a:ext>
            </a:extLst>
          </p:cNvPr>
          <p:cNvSpPr txBox="1"/>
          <p:nvPr/>
        </p:nvSpPr>
        <p:spPr>
          <a:xfrm>
            <a:off x="7437681" y="4040776"/>
            <a:ext cx="3162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Specify____________________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2FE50825-A982-4C26-8B08-DADF9C551462}"/>
              </a:ext>
            </a:extLst>
          </p:cNvPr>
          <p:cNvSpPr/>
          <p:nvPr/>
        </p:nvSpPr>
        <p:spPr>
          <a:xfrm>
            <a:off x="1697612" y="2130126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EECC007D-5F74-47F5-BE0C-5FC6A938016A}"/>
              </a:ext>
            </a:extLst>
          </p:cNvPr>
          <p:cNvSpPr/>
          <p:nvPr/>
        </p:nvSpPr>
        <p:spPr>
          <a:xfrm>
            <a:off x="1905049" y="4329897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601AE7B-C0E8-4A24-9155-2F0159F5E1FA}"/>
              </a:ext>
            </a:extLst>
          </p:cNvPr>
          <p:cNvSpPr/>
          <p:nvPr/>
        </p:nvSpPr>
        <p:spPr>
          <a:xfrm>
            <a:off x="7229134" y="3848152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077C8B-BC6C-4792-B509-F4CA83719D56}"/>
              </a:ext>
            </a:extLst>
          </p:cNvPr>
          <p:cNvSpPr txBox="1"/>
          <p:nvPr/>
        </p:nvSpPr>
        <p:spPr>
          <a:xfrm rot="16200000">
            <a:off x="199559" y="5823045"/>
            <a:ext cx="1413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Danger Signs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3EAD937-0384-4831-A347-F8EDCB943E0B}"/>
              </a:ext>
            </a:extLst>
          </p:cNvPr>
          <p:cNvCxnSpPr>
            <a:cxnSpLocks/>
          </p:cNvCxnSpPr>
          <p:nvPr/>
        </p:nvCxnSpPr>
        <p:spPr>
          <a:xfrm>
            <a:off x="715897" y="5181600"/>
            <a:ext cx="11248053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75B6BC1B-9781-46A3-90C4-DD74AA4B204E}"/>
              </a:ext>
            </a:extLst>
          </p:cNvPr>
          <p:cNvSpPr txBox="1"/>
          <p:nvPr/>
        </p:nvSpPr>
        <p:spPr>
          <a:xfrm>
            <a:off x="1797907" y="5442090"/>
            <a:ext cx="698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Fever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C30C6A4-FC5B-4309-B8BA-82406C42840F}"/>
              </a:ext>
            </a:extLst>
          </p:cNvPr>
          <p:cNvSpPr txBox="1"/>
          <p:nvPr/>
        </p:nvSpPr>
        <p:spPr>
          <a:xfrm>
            <a:off x="1797907" y="5921572"/>
            <a:ext cx="1879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Difficult breathing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A8E40CB-A91B-48B9-99E8-833E69749D0D}"/>
              </a:ext>
            </a:extLst>
          </p:cNvPr>
          <p:cNvSpPr txBox="1"/>
          <p:nvPr/>
        </p:nvSpPr>
        <p:spPr>
          <a:xfrm>
            <a:off x="9485509" y="5397353"/>
            <a:ext cx="1681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No danger sign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23710FD-31EC-4208-B263-3C4654F095AC}"/>
              </a:ext>
            </a:extLst>
          </p:cNvPr>
          <p:cNvSpPr txBox="1"/>
          <p:nvPr/>
        </p:nvSpPr>
        <p:spPr>
          <a:xfrm>
            <a:off x="612895" y="3022201"/>
            <a:ext cx="5867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dirty="0"/>
              <a:t>Duration of Illness:_________________________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365AADD-CB2B-429E-B4CE-6B839EBD5A06}"/>
              </a:ext>
            </a:extLst>
          </p:cNvPr>
          <p:cNvSpPr txBox="1"/>
          <p:nvPr/>
        </p:nvSpPr>
        <p:spPr>
          <a:xfrm>
            <a:off x="2787840" y="2984706"/>
            <a:ext cx="5765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600" dirty="0"/>
              <a:t>Days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10D68EF8-26D9-435F-84DB-992F6463516A}"/>
              </a:ext>
            </a:extLst>
          </p:cNvPr>
          <p:cNvSpPr/>
          <p:nvPr/>
        </p:nvSpPr>
        <p:spPr>
          <a:xfrm>
            <a:off x="2488454" y="2981551"/>
            <a:ext cx="357276" cy="2807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35EE658F-AA24-41BD-9F22-80AC93F84E59}"/>
              </a:ext>
            </a:extLst>
          </p:cNvPr>
          <p:cNvSpPr/>
          <p:nvPr/>
        </p:nvSpPr>
        <p:spPr>
          <a:xfrm>
            <a:off x="3444282" y="3004050"/>
            <a:ext cx="377248" cy="2570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0358BA4-0DC2-42AC-9291-C4880F9480DD}"/>
              </a:ext>
            </a:extLst>
          </p:cNvPr>
          <p:cNvSpPr txBox="1"/>
          <p:nvPr/>
        </p:nvSpPr>
        <p:spPr>
          <a:xfrm>
            <a:off x="3743231" y="2971272"/>
            <a:ext cx="736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600" dirty="0"/>
              <a:t>Weeks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42F1C44E-7CEF-439D-8226-7B9DAA2BAF57}"/>
              </a:ext>
            </a:extLst>
          </p:cNvPr>
          <p:cNvSpPr/>
          <p:nvPr/>
        </p:nvSpPr>
        <p:spPr>
          <a:xfrm>
            <a:off x="4500637" y="2993487"/>
            <a:ext cx="377248" cy="2570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2CCF7D4-A4CC-4A3B-AD0E-A67E40236F75}"/>
              </a:ext>
            </a:extLst>
          </p:cNvPr>
          <p:cNvSpPr txBox="1"/>
          <p:nvPr/>
        </p:nvSpPr>
        <p:spPr>
          <a:xfrm>
            <a:off x="4798676" y="2952642"/>
            <a:ext cx="83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600" dirty="0"/>
              <a:t>Months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421D547-28F8-4B40-8CF8-5D1366464EBD}"/>
              </a:ext>
            </a:extLst>
          </p:cNvPr>
          <p:cNvSpPr/>
          <p:nvPr/>
        </p:nvSpPr>
        <p:spPr>
          <a:xfrm>
            <a:off x="5579481" y="2989093"/>
            <a:ext cx="377248" cy="2570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0E38462-080F-4832-9A8B-F4666E50B0F4}"/>
              </a:ext>
            </a:extLst>
          </p:cNvPr>
          <p:cNvSpPr txBox="1"/>
          <p:nvPr/>
        </p:nvSpPr>
        <p:spPr>
          <a:xfrm>
            <a:off x="5867696" y="2956777"/>
            <a:ext cx="6184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600" dirty="0"/>
              <a:t>Years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07BE3F0D-EB71-4120-81AD-A82181EF7319}"/>
              </a:ext>
            </a:extLst>
          </p:cNvPr>
          <p:cNvSpPr/>
          <p:nvPr/>
        </p:nvSpPr>
        <p:spPr>
          <a:xfrm>
            <a:off x="1588107" y="5546545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8403E21-53AC-403F-9FF8-BCCE2DB13D52}"/>
              </a:ext>
            </a:extLst>
          </p:cNvPr>
          <p:cNvSpPr/>
          <p:nvPr/>
        </p:nvSpPr>
        <p:spPr>
          <a:xfrm>
            <a:off x="1588107" y="6015945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CF21AEE-C2BE-4487-87B2-EE7A0ADAB26B}"/>
              </a:ext>
            </a:extLst>
          </p:cNvPr>
          <p:cNvSpPr/>
          <p:nvPr/>
        </p:nvSpPr>
        <p:spPr>
          <a:xfrm>
            <a:off x="9289558" y="5501808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9EA16C9-F168-48F5-9A80-B6F18481FDB5}"/>
              </a:ext>
            </a:extLst>
          </p:cNvPr>
          <p:cNvSpPr txBox="1"/>
          <p:nvPr/>
        </p:nvSpPr>
        <p:spPr>
          <a:xfrm>
            <a:off x="5250608" y="5426423"/>
            <a:ext cx="1957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Other danger sign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4DC573D-9775-44D2-ABB8-075CCD689F9D}"/>
              </a:ext>
            </a:extLst>
          </p:cNvPr>
          <p:cNvSpPr txBox="1"/>
          <p:nvPr/>
        </p:nvSpPr>
        <p:spPr>
          <a:xfrm>
            <a:off x="5250608" y="5733980"/>
            <a:ext cx="3162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Specify____________________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BDE7136B-323D-4931-8BA8-E691AFD81F56}"/>
              </a:ext>
            </a:extLst>
          </p:cNvPr>
          <p:cNvSpPr/>
          <p:nvPr/>
        </p:nvSpPr>
        <p:spPr>
          <a:xfrm>
            <a:off x="5042061" y="5541356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968B90-4083-4820-8949-04603F0A40DE}"/>
              </a:ext>
            </a:extLst>
          </p:cNvPr>
          <p:cNvSpPr txBox="1"/>
          <p:nvPr/>
        </p:nvSpPr>
        <p:spPr>
          <a:xfrm>
            <a:off x="9768840" y="376234"/>
            <a:ext cx="1188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HO Logo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10C6815-80DA-4604-854D-8424EFDF7D02}"/>
              </a:ext>
            </a:extLst>
          </p:cNvPr>
          <p:cNvSpPr txBox="1"/>
          <p:nvPr/>
        </p:nvSpPr>
        <p:spPr>
          <a:xfrm>
            <a:off x="661307" y="415074"/>
            <a:ext cx="1417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PHP Logo</a:t>
            </a:r>
          </a:p>
        </p:txBody>
      </p:sp>
    </p:spTree>
    <p:extLst>
      <p:ext uri="{BB962C8B-B14F-4D97-AF65-F5344CB8AC3E}">
        <p14:creationId xmlns:p14="http://schemas.microsoft.com/office/powerpoint/2010/main" val="42727202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D07BFF4-77A2-40C2-A02F-A43AEF1C7E67}"/>
              </a:ext>
            </a:extLst>
          </p:cNvPr>
          <p:cNvSpPr txBox="1"/>
          <p:nvPr/>
        </p:nvSpPr>
        <p:spPr>
          <a:xfrm rot="16200000">
            <a:off x="-128625" y="663216"/>
            <a:ext cx="13838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Core referral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44C5507-2559-4BE2-A304-BEF77D59FC2C}"/>
              </a:ext>
            </a:extLst>
          </p:cNvPr>
          <p:cNvSpPr txBox="1"/>
          <p:nvPr/>
        </p:nvSpPr>
        <p:spPr>
          <a:xfrm>
            <a:off x="1455007" y="282261"/>
            <a:ext cx="2292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Nearest Health Facilit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A83737-2047-41E7-90B8-79CCE1B6230C}"/>
              </a:ext>
            </a:extLst>
          </p:cNvPr>
          <p:cNvSpPr txBox="1"/>
          <p:nvPr/>
        </p:nvSpPr>
        <p:spPr>
          <a:xfrm>
            <a:off x="1455007" y="761743"/>
            <a:ext cx="2359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Notified the focal poin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4E0A463-52A7-49D6-9462-4D9A1CEA7F4F}"/>
              </a:ext>
            </a:extLst>
          </p:cNvPr>
          <p:cNvSpPr txBox="1"/>
          <p:nvPr/>
        </p:nvSpPr>
        <p:spPr>
          <a:xfrm>
            <a:off x="5767667" y="264983"/>
            <a:ext cx="3724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Advised to stay home on self isolatio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B22810D-17A5-49C1-88F9-2F0805FDBFC5}"/>
              </a:ext>
            </a:extLst>
          </p:cNvPr>
          <p:cNvSpPr/>
          <p:nvPr/>
        </p:nvSpPr>
        <p:spPr>
          <a:xfrm>
            <a:off x="1246460" y="386716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1869B6B-8BEE-4928-994B-B81DC9B9C731}"/>
              </a:ext>
            </a:extLst>
          </p:cNvPr>
          <p:cNvSpPr/>
          <p:nvPr/>
        </p:nvSpPr>
        <p:spPr>
          <a:xfrm>
            <a:off x="1246459" y="866198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F9982BF-797B-4B2C-90F3-D1E44F1A8F6A}"/>
              </a:ext>
            </a:extLst>
          </p:cNvPr>
          <p:cNvSpPr/>
          <p:nvPr/>
        </p:nvSpPr>
        <p:spPr>
          <a:xfrm>
            <a:off x="5559120" y="369438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F7040E18-8195-4D49-BBAD-636B6AAD8CF2}"/>
              </a:ext>
            </a:extLst>
          </p:cNvPr>
          <p:cNvCxnSpPr>
            <a:cxnSpLocks/>
          </p:cNvCxnSpPr>
          <p:nvPr/>
        </p:nvCxnSpPr>
        <p:spPr>
          <a:xfrm>
            <a:off x="471973" y="1646464"/>
            <a:ext cx="11248053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7C8E66B8-180D-46ED-890B-ED4934A15FDA}"/>
              </a:ext>
            </a:extLst>
          </p:cNvPr>
          <p:cNvSpPr txBox="1"/>
          <p:nvPr/>
        </p:nvSpPr>
        <p:spPr>
          <a:xfrm>
            <a:off x="378628" y="3429000"/>
            <a:ext cx="2961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Describe any treatment take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F36870-875A-4B82-8B37-865C0647DFA9}"/>
              </a:ext>
            </a:extLst>
          </p:cNvPr>
          <p:cNvSpPr txBox="1"/>
          <p:nvPr/>
        </p:nvSpPr>
        <p:spPr>
          <a:xfrm rot="16200000">
            <a:off x="-130979" y="2253153"/>
            <a:ext cx="1575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b="1" dirty="0"/>
              <a:t>Case detecte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D0656C5-63F1-42CF-9046-E096192FBF58}"/>
              </a:ext>
            </a:extLst>
          </p:cNvPr>
          <p:cNvSpPr txBox="1"/>
          <p:nvPr/>
        </p:nvSpPr>
        <p:spPr>
          <a:xfrm>
            <a:off x="1548351" y="1984748"/>
            <a:ext cx="2441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Through household visi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593DA8-2A74-4296-B432-9D9ECA290B71}"/>
              </a:ext>
            </a:extLst>
          </p:cNvPr>
          <p:cNvSpPr txBox="1"/>
          <p:nvPr/>
        </p:nvSpPr>
        <p:spPr>
          <a:xfrm>
            <a:off x="1548351" y="2464230"/>
            <a:ext cx="2847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During community meeting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F02C21A-EF33-43C5-8188-03A1A6AD28B6}"/>
              </a:ext>
            </a:extLst>
          </p:cNvPr>
          <p:cNvSpPr txBox="1"/>
          <p:nvPr/>
        </p:nvSpPr>
        <p:spPr>
          <a:xfrm>
            <a:off x="5917158" y="2466695"/>
            <a:ext cx="8170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Others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AEF2F79-E59D-495A-B1B6-44F49B600261}"/>
              </a:ext>
            </a:extLst>
          </p:cNvPr>
          <p:cNvSpPr/>
          <p:nvPr/>
        </p:nvSpPr>
        <p:spPr>
          <a:xfrm>
            <a:off x="1339804" y="2089203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AD5CFCA-F980-458F-9690-C64EFF1C03DD}"/>
              </a:ext>
            </a:extLst>
          </p:cNvPr>
          <p:cNvSpPr/>
          <p:nvPr/>
        </p:nvSpPr>
        <p:spPr>
          <a:xfrm>
            <a:off x="1339803" y="2568685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5B01CE-4DC2-41AF-A072-ECD8341C563C}"/>
              </a:ext>
            </a:extLst>
          </p:cNvPr>
          <p:cNvSpPr/>
          <p:nvPr/>
        </p:nvSpPr>
        <p:spPr>
          <a:xfrm>
            <a:off x="5708611" y="2571150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A2F29B8-2A56-4BDA-8CD6-5F0D35715F94}"/>
              </a:ext>
            </a:extLst>
          </p:cNvPr>
          <p:cNvSpPr txBox="1"/>
          <p:nvPr/>
        </p:nvSpPr>
        <p:spPr>
          <a:xfrm>
            <a:off x="5615267" y="2883428"/>
            <a:ext cx="3162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Specify____________________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09B5E11-4891-407C-9B9A-B29F68CEE8C3}"/>
              </a:ext>
            </a:extLst>
          </p:cNvPr>
          <p:cNvCxnSpPr>
            <a:cxnSpLocks/>
          </p:cNvCxnSpPr>
          <p:nvPr/>
        </p:nvCxnSpPr>
        <p:spPr>
          <a:xfrm>
            <a:off x="471973" y="3306822"/>
            <a:ext cx="11248053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778B1AFE-559A-4521-9CEB-5497401181FC}"/>
              </a:ext>
            </a:extLst>
          </p:cNvPr>
          <p:cNvSpPr txBox="1"/>
          <p:nvPr/>
        </p:nvSpPr>
        <p:spPr>
          <a:xfrm>
            <a:off x="5917158" y="1824206"/>
            <a:ext cx="1539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In the mosque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B81DA2F6-8BB2-4EA4-B7D5-1B77C91F82F8}"/>
              </a:ext>
            </a:extLst>
          </p:cNvPr>
          <p:cNvSpPr/>
          <p:nvPr/>
        </p:nvSpPr>
        <p:spPr>
          <a:xfrm>
            <a:off x="5708610" y="1928661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CF21492-E337-41B0-8BBB-8A3632AC0B4E}"/>
              </a:ext>
            </a:extLst>
          </p:cNvPr>
          <p:cNvSpPr txBox="1"/>
          <p:nvPr/>
        </p:nvSpPr>
        <p:spPr>
          <a:xfrm>
            <a:off x="9113702" y="1850959"/>
            <a:ext cx="1186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In a school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C1E9125-E2B3-4A17-B25A-B29C38398056}"/>
              </a:ext>
            </a:extLst>
          </p:cNvPr>
          <p:cNvSpPr/>
          <p:nvPr/>
        </p:nvSpPr>
        <p:spPr>
          <a:xfrm>
            <a:off x="8905154" y="1955414"/>
            <a:ext cx="208547" cy="1604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5082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02</TotalTime>
  <Words>120</Words>
  <Application>Microsoft Office PowerPoint</Application>
  <PresentationFormat>Widescreen</PresentationFormat>
  <Paragraphs>4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munity Based Surveillance</dc:title>
  <dc:creator>BAAEES, Manal</dc:creator>
  <cp:lastModifiedBy>NAIENE, Jeremias Domingos</cp:lastModifiedBy>
  <cp:revision>39</cp:revision>
  <dcterms:created xsi:type="dcterms:W3CDTF">2020-04-11T22:08:41Z</dcterms:created>
  <dcterms:modified xsi:type="dcterms:W3CDTF">2021-04-23T13:15:53Z</dcterms:modified>
</cp:coreProperties>
</file>